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EC3D9-DCE3-4C44-8369-9B91D96AEA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1BFC0-0159-4C0D-B700-53254143E1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3BD21-45AB-433D-AB11-2F1BE3F757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771E2-BB94-4EED-ADD5-9CABEFB075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6BACD-2EA2-482A-97FC-8BDBA43D03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3663E-27ED-4504-94FC-2083446C75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3F177-9364-4F9A-81F8-8501554E26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13853-BC2A-4AA3-A360-5D398D4F0E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DA28C-3698-4901-A9A6-1EC70C4E74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4C965-FDE1-405C-BD01-85D211E77C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353AB-7668-4F39-BB77-B34E908DD4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BA5E0-3E56-4CA7-9942-EC291F33CE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562EE9-2095-4C53-91C0-094D4D630623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68"/>
          <p:cNvGrpSpPr/>
          <p:nvPr/>
        </p:nvGrpSpPr>
        <p:grpSpPr>
          <a:xfrm>
            <a:off x="2139840" y="1681200"/>
            <a:ext cx="5022720" cy="4108680"/>
            <a:chOff x="2139840" y="1681200"/>
            <a:chExt cx="5022720" cy="4108680"/>
          </a:xfrm>
        </p:grpSpPr>
        <p:grpSp>
          <p:nvGrpSpPr>
            <p:cNvPr id="42" name="Gruppo 58"/>
            <p:cNvGrpSpPr/>
            <p:nvPr/>
          </p:nvGrpSpPr>
          <p:grpSpPr>
            <a:xfrm>
              <a:off x="2139840" y="1681200"/>
              <a:ext cx="5022720" cy="4108680"/>
              <a:chOff x="2139840" y="1681200"/>
              <a:chExt cx="5022720" cy="4108680"/>
            </a:xfrm>
          </p:grpSpPr>
          <p:sp>
            <p:nvSpPr>
              <p:cNvPr id="43" name="Rectangle 102"/>
              <p:cNvSpPr/>
              <p:nvPr/>
            </p:nvSpPr>
            <p:spPr>
              <a:xfrm>
                <a:off x="3432960" y="1681200"/>
                <a:ext cx="266616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600" spc="-1" strike="noStrike">
                    <a:solidFill>
                      <a:srgbClr val="000000"/>
                    </a:solidFill>
                    <a:latin typeface="Times New Roman"/>
                  </a:rPr>
                  <a:t>CTLA-4 transcript expression 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Group 100"/>
              <p:cNvGrpSpPr/>
              <p:nvPr/>
            </p:nvGrpSpPr>
            <p:grpSpPr>
              <a:xfrm>
                <a:off x="2139840" y="2274120"/>
                <a:ext cx="5022720" cy="3515760"/>
                <a:chOff x="2139840" y="2274120"/>
                <a:chExt cx="5022720" cy="3515760"/>
              </a:xfrm>
            </p:grpSpPr>
            <p:sp>
              <p:nvSpPr>
                <p:cNvPr id="45" name="Line 84"/>
                <p:cNvSpPr/>
                <p:nvPr/>
              </p:nvSpPr>
              <p:spPr>
                <a:xfrm flipV="1">
                  <a:off x="4526280" y="4344480"/>
                  <a:ext cx="0" cy="41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Line 85"/>
                <p:cNvSpPr/>
                <p:nvPr/>
              </p:nvSpPr>
              <p:spPr>
                <a:xfrm>
                  <a:off x="4488480" y="4344480"/>
                  <a:ext cx="88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Line 86"/>
                <p:cNvSpPr/>
                <p:nvPr/>
              </p:nvSpPr>
              <p:spPr>
                <a:xfrm>
                  <a:off x="4526280" y="4386600"/>
                  <a:ext cx="0" cy="41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Line 92"/>
                <p:cNvSpPr/>
                <p:nvPr/>
              </p:nvSpPr>
              <p:spPr>
                <a:xfrm>
                  <a:off x="2882880" y="2386800"/>
                  <a:ext cx="0" cy="30981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Line 93"/>
                <p:cNvSpPr/>
                <p:nvPr/>
              </p:nvSpPr>
              <p:spPr>
                <a:xfrm>
                  <a:off x="2832120" y="548496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Line 94"/>
                <p:cNvSpPr/>
                <p:nvPr/>
              </p:nvSpPr>
              <p:spPr>
                <a:xfrm>
                  <a:off x="2832120" y="486504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Line 95"/>
                <p:cNvSpPr/>
                <p:nvPr/>
              </p:nvSpPr>
              <p:spPr>
                <a:xfrm>
                  <a:off x="2832120" y="424548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Line 96"/>
                <p:cNvSpPr/>
                <p:nvPr/>
              </p:nvSpPr>
              <p:spPr>
                <a:xfrm>
                  <a:off x="2832120" y="362592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Line 97"/>
                <p:cNvSpPr/>
                <p:nvPr/>
              </p:nvSpPr>
              <p:spPr>
                <a:xfrm>
                  <a:off x="2832120" y="300636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Line 98"/>
                <p:cNvSpPr/>
                <p:nvPr/>
              </p:nvSpPr>
              <p:spPr>
                <a:xfrm>
                  <a:off x="2832120" y="2386800"/>
                  <a:ext cx="50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Line 99"/>
                <p:cNvSpPr/>
                <p:nvPr/>
              </p:nvSpPr>
              <p:spPr>
                <a:xfrm>
                  <a:off x="2882880" y="5484960"/>
                  <a:ext cx="4279320" cy="3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Line 100"/>
                <p:cNvSpPr/>
                <p:nvPr/>
              </p:nvSpPr>
              <p:spPr>
                <a:xfrm flipV="1">
                  <a:off x="2882880" y="5484600"/>
                  <a:ext cx="0" cy="55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Line 101"/>
                <p:cNvSpPr/>
                <p:nvPr/>
              </p:nvSpPr>
              <p:spPr>
                <a:xfrm flipV="1">
                  <a:off x="7162560" y="5484600"/>
                  <a:ext cx="0" cy="55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Rectangle 103"/>
                <p:cNvSpPr/>
                <p:nvPr/>
              </p:nvSpPr>
              <p:spPr>
                <a:xfrm>
                  <a:off x="2673000" y="5372280"/>
                  <a:ext cx="77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Rectangle 104"/>
                <p:cNvSpPr/>
                <p:nvPr/>
              </p:nvSpPr>
              <p:spPr>
                <a:xfrm>
                  <a:off x="2508120" y="4752720"/>
                  <a:ext cx="229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4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Rectangle 105"/>
                <p:cNvSpPr/>
                <p:nvPr/>
              </p:nvSpPr>
              <p:spPr>
                <a:xfrm>
                  <a:off x="2508120" y="4133160"/>
                  <a:ext cx="2293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8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Rectangle 106"/>
                <p:cNvSpPr/>
                <p:nvPr/>
              </p:nvSpPr>
              <p:spPr>
                <a:xfrm>
                  <a:off x="2425320" y="3512880"/>
                  <a:ext cx="305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12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107"/>
                <p:cNvSpPr/>
                <p:nvPr/>
              </p:nvSpPr>
              <p:spPr>
                <a:xfrm>
                  <a:off x="2425320" y="2893320"/>
                  <a:ext cx="305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16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108"/>
                <p:cNvSpPr/>
                <p:nvPr/>
              </p:nvSpPr>
              <p:spPr>
                <a:xfrm>
                  <a:off x="2425320" y="2274120"/>
                  <a:ext cx="3056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200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109"/>
                <p:cNvSpPr/>
                <p:nvPr/>
              </p:nvSpPr>
              <p:spPr>
                <a:xfrm rot="16200000">
                  <a:off x="920160" y="3810240"/>
                  <a:ext cx="2621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Mean of normalized expression +/- SEM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112"/>
                <p:cNvSpPr/>
                <p:nvPr/>
              </p:nvSpPr>
              <p:spPr>
                <a:xfrm>
                  <a:off x="3394080" y="5595120"/>
                  <a:ext cx="3391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FO-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126"/>
                <p:cNvSpPr/>
                <p:nvPr/>
              </p:nvSpPr>
              <p:spPr>
                <a:xfrm>
                  <a:off x="4210920" y="2919600"/>
                  <a:ext cx="1016280" cy="257688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Line 127"/>
                <p:cNvSpPr/>
                <p:nvPr/>
              </p:nvSpPr>
              <p:spPr>
                <a:xfrm flipV="1">
                  <a:off x="4718880" y="2721960"/>
                  <a:ext cx="0" cy="1972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Line 128"/>
                <p:cNvSpPr/>
                <p:nvPr/>
              </p:nvSpPr>
              <p:spPr>
                <a:xfrm>
                  <a:off x="4681080" y="2721960"/>
                  <a:ext cx="885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129"/>
                <p:cNvSpPr/>
                <p:nvPr/>
              </p:nvSpPr>
              <p:spPr>
                <a:xfrm>
                  <a:off x="4718880" y="2919600"/>
                  <a:ext cx="0" cy="210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130"/>
                <p:cNvSpPr/>
                <p:nvPr/>
              </p:nvSpPr>
              <p:spPr>
                <a:xfrm>
                  <a:off x="4681080" y="3130920"/>
                  <a:ext cx="885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131"/>
                <p:cNvSpPr/>
                <p:nvPr/>
              </p:nvSpPr>
              <p:spPr>
                <a:xfrm>
                  <a:off x="4506120" y="5607000"/>
                  <a:ext cx="416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Tissue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136"/>
                <p:cNvSpPr/>
                <p:nvPr/>
              </p:nvSpPr>
              <p:spPr>
                <a:xfrm>
                  <a:off x="5432760" y="4398120"/>
                  <a:ext cx="1028880" cy="109836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137"/>
                <p:cNvSpPr/>
                <p:nvPr/>
              </p:nvSpPr>
              <p:spPr>
                <a:xfrm flipV="1">
                  <a:off x="5941080" y="4356000"/>
                  <a:ext cx="0" cy="417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Line 138"/>
                <p:cNvSpPr/>
                <p:nvPr/>
              </p:nvSpPr>
              <p:spPr>
                <a:xfrm>
                  <a:off x="5902920" y="4356000"/>
                  <a:ext cx="885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139"/>
                <p:cNvSpPr/>
                <p:nvPr/>
              </p:nvSpPr>
              <p:spPr>
                <a:xfrm>
                  <a:off x="5941080" y="4398120"/>
                  <a:ext cx="0" cy="417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040" bIns="-5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Line 140"/>
                <p:cNvSpPr/>
                <p:nvPr/>
              </p:nvSpPr>
              <p:spPr>
                <a:xfrm>
                  <a:off x="5902920" y="4440240"/>
                  <a:ext cx="885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141"/>
                <p:cNvSpPr/>
                <p:nvPr/>
              </p:nvSpPr>
              <p:spPr>
                <a:xfrm>
                  <a:off x="5695200" y="5607000"/>
                  <a:ext cx="6098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Times New Roman"/>
                    </a:rPr>
                    <a:t>METR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8" name="Connettore 1 5"/>
            <p:cNvSpPr/>
            <p:nvPr/>
          </p:nvSpPr>
          <p:spPr>
            <a:xfrm>
              <a:off x="3047760" y="5461200"/>
              <a:ext cx="971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CasellaDiTesto 41"/>
          <p:cNvSpPr/>
          <p:nvPr/>
        </p:nvSpPr>
        <p:spPr>
          <a:xfrm>
            <a:off x="971640" y="260280"/>
            <a:ext cx="2592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0T12:49:50Z</dcterms:created>
  <dc:creator>RIC TRASL A</dc:creator>
  <dc:description/>
  <dc:language>en-US</dc:language>
  <cp:lastModifiedBy>Xp Professional SP 3 Italiano</cp:lastModifiedBy>
  <dcterms:modified xsi:type="dcterms:W3CDTF">2012-12-18T11:38:11Z</dcterms:modified>
  <cp:revision>247</cp:revision>
  <dc:subject/>
  <dc:title>Diapositiva 1</dc:title>
</cp:coreProperties>
</file>